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56" r:id="rId2"/>
    <p:sldId id="377" r:id="rId3"/>
    <p:sldId id="372" r:id="rId4"/>
    <p:sldId id="371" r:id="rId5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10" autoAdjust="0"/>
    <p:restoredTop sz="95255" autoAdjust="0"/>
  </p:normalViewPr>
  <p:slideViewPr>
    <p:cSldViewPr>
      <p:cViewPr varScale="1">
        <p:scale>
          <a:sx n="82" d="100"/>
          <a:sy n="82" d="100"/>
        </p:scale>
        <p:origin x="2910" y="12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E52B42-2097-4F88-8CCC-416F07181C37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DAEFAB-0484-4E6B-9F13-F40C036162F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38784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AB2BD-AE83-449E-AEF2-D03DED9554CC}" type="datetimeFigureOut">
              <a:rPr lang="ko-KR" altLang="en-US" smtClean="0"/>
              <a:pPr/>
              <a:t>2021-10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E6351E-65D0-47EF-9FC7-12A3E58986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2" Type="http://schemas.openxmlformats.org/officeDocument/2006/relationships/image" Target="../media/image9.w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-1971600" y="7088"/>
            <a:ext cx="6641298" cy="664513"/>
          </a:xfrm>
        </p:spPr>
        <p:txBody>
          <a:bodyPr>
            <a:noAutofit/>
          </a:bodyPr>
          <a:lstStyle/>
          <a:p>
            <a:r>
              <a:rPr lang="en-US" altLang="ko-KR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</a:t>
            </a:r>
            <a:r>
              <a:rPr lang="en-US" altLang="ko-K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ko-KR" alt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ko-KR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2" descr="http://bioinformatics.psb.ugent.be/readwrite/Venn_tmp/Downl/venn_result5020.png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5360" y="1199351"/>
            <a:ext cx="2808312" cy="2292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타원 2"/>
          <p:cNvSpPr/>
          <p:nvPr/>
        </p:nvSpPr>
        <p:spPr>
          <a:xfrm>
            <a:off x="1711168" y="2165731"/>
            <a:ext cx="432048" cy="36004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6" name="직선 화살표 연결선 5"/>
          <p:cNvCxnSpPr/>
          <p:nvPr/>
        </p:nvCxnSpPr>
        <p:spPr>
          <a:xfrm>
            <a:off x="2224188" y="2247505"/>
            <a:ext cx="2218556" cy="406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9402512"/>
              </p:ext>
            </p:extLst>
          </p:nvPr>
        </p:nvGraphicFramePr>
        <p:xfrm>
          <a:off x="4519480" y="2225857"/>
          <a:ext cx="2016223" cy="59982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16223">
                  <a:extLst>
                    <a:ext uri="{9D8B030D-6E8A-4147-A177-3AD203B41FA5}">
                      <a16:colId xmlns:a16="http://schemas.microsoft.com/office/drawing/2014/main" val="4291979455"/>
                    </a:ext>
                  </a:extLst>
                </a:gridCol>
              </a:tblGrid>
              <a:tr h="233078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lapping</a:t>
                      </a:r>
                      <a:r>
                        <a:rPr lang="en-US" altLang="ko-KR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rget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8918776"/>
                  </a:ext>
                </a:extLst>
              </a:tr>
              <a:tr h="32550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F</a:t>
                      </a:r>
                      <a:r>
                        <a:rPr lang="en-US" altLang="ko-KR" sz="11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3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2361128"/>
                  </a:ext>
                </a:extLst>
              </a:tr>
            </a:tbl>
          </a:graphicData>
        </a:graphic>
      </p:graphicFrame>
      <p:graphicFrame>
        <p:nvGraphicFramePr>
          <p:cNvPr id="13" name="개체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5675840"/>
              </p:ext>
            </p:extLst>
          </p:nvPr>
        </p:nvGraphicFramePr>
        <p:xfrm>
          <a:off x="1620125" y="3621344"/>
          <a:ext cx="4896544" cy="25532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158" name="Prism 8" r:id="rId4" imgW="4318993" imgH="2960383" progId="Prism8.Document">
                  <p:embed/>
                </p:oleObj>
              </mc:Choice>
              <mc:Fallback>
                <p:oleObj name="Prism 8" r:id="rId4" imgW="4318993" imgH="296038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20125" y="3621344"/>
                        <a:ext cx="4896544" cy="25532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개체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006494"/>
              </p:ext>
            </p:extLst>
          </p:nvPr>
        </p:nvGraphicFramePr>
        <p:xfrm>
          <a:off x="-35952" y="6108640"/>
          <a:ext cx="6381328" cy="30353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159" name="Prism 8" r:id="rId6" imgW="6696474" imgH="2971181" progId="Prism8.Document">
                  <p:embed/>
                </p:oleObj>
              </mc:Choice>
              <mc:Fallback>
                <p:oleObj name="Prism 8" r:id="rId6" imgW="6696474" imgH="297118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35952" y="6108640"/>
                        <a:ext cx="6381328" cy="30353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직사각형 15"/>
          <p:cNvSpPr/>
          <p:nvPr/>
        </p:nvSpPr>
        <p:spPr>
          <a:xfrm>
            <a:off x="47425" y="690059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47425" y="3667021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47425" y="5896698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7947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2908271"/>
              </p:ext>
            </p:extLst>
          </p:nvPr>
        </p:nvGraphicFramePr>
        <p:xfrm>
          <a:off x="474663" y="1238250"/>
          <a:ext cx="2651125" cy="2455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652" name="Prism 8" r:id="rId3" imgW="3337617" imgH="2741189" progId="Prism8.Document">
                  <p:embed/>
                </p:oleObj>
              </mc:Choice>
              <mc:Fallback>
                <p:oleObj name="Prism 8" r:id="rId3" imgW="3337617" imgH="2741189" progId="Prism8.Document">
                  <p:embed/>
                  <p:pic>
                    <p:nvPicPr>
                      <p:cNvPr id="17" name="개체 1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4663" y="1238250"/>
                        <a:ext cx="2651125" cy="2455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0999160"/>
              </p:ext>
            </p:extLst>
          </p:nvPr>
        </p:nvGraphicFramePr>
        <p:xfrm>
          <a:off x="3645024" y="1227568"/>
          <a:ext cx="2824162" cy="2403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5653" name="Prism 8" r:id="rId5" imgW="3452099" imgH="3064041" progId="Prism8.Document">
                  <p:embed/>
                </p:oleObj>
              </mc:Choice>
              <mc:Fallback>
                <p:oleObj name="Prism 8" r:id="rId5" imgW="3452099" imgH="3064041" progId="Prism8.Document">
                  <p:embed/>
                  <p:pic>
                    <p:nvPicPr>
                      <p:cNvPr id="18" name="개체 17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45024" y="1227568"/>
                        <a:ext cx="2824162" cy="2403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95739" y="7246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3573016" y="677144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188640" y="128886"/>
            <a:ext cx="27004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 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0876921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476672" y="1331640"/>
            <a:ext cx="4967235" cy="2331654"/>
            <a:chOff x="55351" y="323528"/>
            <a:chExt cx="6397064" cy="2868352"/>
          </a:xfrm>
        </p:grpSpPr>
        <p:pic>
          <p:nvPicPr>
            <p:cNvPr id="5" name="Picture 2" descr="C:\Users\손은정\Desktop\동아대대대대\confocal\endogenous schwann cell P2Rx and s100\SWC_P2RX4(green)_S100(red)_400x\SWC_P2RX4(green)_S100(red)_400x-4\SWC_P2RX4(green)_S100(red)_400x-4_c1+2+3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80200" y="787595"/>
              <a:ext cx="1972215" cy="165534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3" descr="C:\Users\손은정\Desktop\동아대대대대\confocal\endogenous schwann cell P2Rx and s100\SWC_P2RX4(green)_S100(red)_400x\SWC_P2RX4(green)_S100(red)_400x-4\SWC_P2RX4(green)_S100(red)_400x-4_c2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689" y="786641"/>
              <a:ext cx="1972591" cy="16572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4" descr="C:\Users\손은정\Desktop\동아대대대대\confocal\endogenous schwann cell P2Rx and s100\SWC_P2RX4(green)_S100(red)_400x\SWC_P2RX4(green)_S100(red)_400x-4\SWC_P2RX4(green)_S100(red)_400x-4_c3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43963" y="788447"/>
              <a:ext cx="1972215" cy="16705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318727" y="2180614"/>
              <a:ext cx="1288618" cy="3407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do P2RX4</a:t>
              </a:r>
              <a:endParaRPr lang="ko-KR" altLang="en-US" sz="1200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356090" y="2180613"/>
              <a:ext cx="1080110" cy="3407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do s100</a:t>
              </a:r>
              <a:endParaRPr lang="ko-KR" altLang="en-US" sz="1200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4421403" y="2180613"/>
              <a:ext cx="748315" cy="3407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rg</a:t>
              </a:r>
              <a:r>
                <a:rPr lang="en-US" altLang="ko-KR" sz="1200" dirty="0">
                  <a:solidFill>
                    <a:srgbClr val="FFFFFF"/>
                  </a:solidFill>
                </a:rPr>
                <a:t>e</a:t>
              </a:r>
              <a:endParaRPr lang="ko-KR" altLang="en-US" sz="1200" dirty="0">
                <a:solidFill>
                  <a:srgbClr val="FFFFFF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38997" y="323528"/>
              <a:ext cx="237906" cy="454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5351" y="323529"/>
              <a:ext cx="237906" cy="454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ko-KR" alt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785106" y="2894244"/>
              <a:ext cx="203569" cy="2976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ko-KR" alt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65853" y="2847835"/>
              <a:ext cx="203569" cy="3307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ko-KR" altLang="en-US" sz="1400" dirty="0">
                <a:solidFill>
                  <a:schemeClr val="tx2">
                    <a:lumMod val="40000"/>
                    <a:lumOff val="60000"/>
                  </a:schemeClr>
                </a:solidFill>
              </a:endParaRP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61595" y="25354"/>
            <a:ext cx="3240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직선 연결선 2"/>
          <p:cNvCxnSpPr/>
          <p:nvPr/>
        </p:nvCxnSpPr>
        <p:spPr>
          <a:xfrm>
            <a:off x="1340768" y="755576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220490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그룹 20"/>
          <p:cNvGrpSpPr/>
          <p:nvPr/>
        </p:nvGrpSpPr>
        <p:grpSpPr>
          <a:xfrm>
            <a:off x="519646" y="1237403"/>
            <a:ext cx="6653769" cy="2047772"/>
            <a:chOff x="1108168" y="745226"/>
            <a:chExt cx="4841112" cy="1267595"/>
          </a:xfrm>
        </p:grpSpPr>
        <p:grpSp>
          <p:nvGrpSpPr>
            <p:cNvPr id="5" name="그룹 4"/>
            <p:cNvGrpSpPr/>
            <p:nvPr/>
          </p:nvGrpSpPr>
          <p:grpSpPr>
            <a:xfrm>
              <a:off x="2276872" y="745226"/>
              <a:ext cx="3672408" cy="1267595"/>
              <a:chOff x="-468803" y="3635863"/>
              <a:chExt cx="7727815" cy="1852511"/>
            </a:xfrm>
          </p:grpSpPr>
          <p:pic>
            <p:nvPicPr>
              <p:cNvPr id="6" name="그림 5"/>
              <p:cNvPicPr/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468803" y="3938974"/>
                <a:ext cx="2273300" cy="1549400"/>
              </a:xfrm>
              <a:prstGeom prst="rect">
                <a:avLst/>
              </a:prstGeom>
            </p:spPr>
          </p:pic>
          <p:pic>
            <p:nvPicPr>
              <p:cNvPr id="7" name="그림 6"/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901188" y="3919924"/>
                <a:ext cx="2369349" cy="1568448"/>
              </a:xfrm>
              <a:prstGeom prst="rect">
                <a:avLst/>
              </a:prstGeom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129119" y="3726396"/>
                <a:ext cx="1026365" cy="2505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DNA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173865" y="3718043"/>
                <a:ext cx="1823994" cy="2505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DNA-P2RX4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flipH="1">
                <a:off x="4270537" y="3635863"/>
                <a:ext cx="2988475" cy="3148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ko-KR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1" name="Picture 2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08168" y="960669"/>
              <a:ext cx="1079742" cy="10521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" name="TextBox 13"/>
            <p:cNvSpPr txBox="1"/>
            <p:nvPr/>
          </p:nvSpPr>
          <p:spPr>
            <a:xfrm>
              <a:off x="1477779" y="811774"/>
              <a:ext cx="474493" cy="171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h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" name="직사각형 19"/>
          <p:cNvSpPr/>
          <p:nvPr/>
        </p:nvSpPr>
        <p:spPr>
          <a:xfrm>
            <a:off x="174195" y="136280"/>
            <a:ext cx="3429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ko-KR" altLang="en-US" dirty="0"/>
          </a:p>
        </p:txBody>
      </p:sp>
      <p:cxnSp>
        <p:nvCxnSpPr>
          <p:cNvPr id="24" name="직선 연결선 23"/>
          <p:cNvCxnSpPr/>
          <p:nvPr/>
        </p:nvCxnSpPr>
        <p:spPr>
          <a:xfrm>
            <a:off x="534481" y="2155276"/>
            <a:ext cx="14691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/>
          <p:cNvCxnSpPr/>
          <p:nvPr/>
        </p:nvCxnSpPr>
        <p:spPr>
          <a:xfrm>
            <a:off x="2125948" y="2155276"/>
            <a:ext cx="14691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>
          <a:xfrm>
            <a:off x="3673921" y="2155276"/>
            <a:ext cx="15475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>
            <a:off x="519646" y="2843808"/>
            <a:ext cx="14691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/>
          <p:cNvCxnSpPr/>
          <p:nvPr/>
        </p:nvCxnSpPr>
        <p:spPr>
          <a:xfrm>
            <a:off x="2134002" y="2843808"/>
            <a:ext cx="146919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3680892" y="2843808"/>
            <a:ext cx="15405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/>
          <p:cNvCxnSpPr/>
          <p:nvPr/>
        </p:nvCxnSpPr>
        <p:spPr>
          <a:xfrm>
            <a:off x="2197757" y="1337478"/>
            <a:ext cx="29523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3168654" y="1046411"/>
            <a:ext cx="5052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1010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67</TotalTime>
  <Words>36</Words>
  <Application>Microsoft Office PowerPoint</Application>
  <PresentationFormat>On-screen Show (4:3)</PresentationFormat>
  <Paragraphs>18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Prism 8</vt:lpstr>
      <vt:lpstr>Supplementary Figure S1.  </vt:lpstr>
      <vt:lpstr>PowerPoint Presentation</vt:lpstr>
      <vt:lpstr>PowerPoint Presentation</vt:lpstr>
      <vt:lpstr>PowerPoint Presentation</vt:lpstr>
    </vt:vector>
  </TitlesOfParts>
  <Company>XP SP3 FIN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Beom</dc:creator>
  <cp:lastModifiedBy>MDPI-49</cp:lastModifiedBy>
  <cp:revision>1925</cp:revision>
  <cp:lastPrinted>2018-11-05T07:15:25Z</cp:lastPrinted>
  <dcterms:created xsi:type="dcterms:W3CDTF">2012-07-26T06:55:51Z</dcterms:created>
  <dcterms:modified xsi:type="dcterms:W3CDTF">2021-10-27T10:47:16Z</dcterms:modified>
</cp:coreProperties>
</file>